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120" d="100"/>
          <a:sy n="120" d="100"/>
        </p:scale>
        <p:origin x="20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921209-9C66-E2B4-7357-B026E37C563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860E82F-10BA-D4C8-9C12-E807976059B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736DA4-F25C-90A9-EA2F-4206EC9363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F1-E2F4-E14E-9734-C819C2A9CFE6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0C9C42-2112-B542-C12C-2FD34C34C9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5AA3C4-B4CA-2735-CF39-361E0DDC6F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9AAB8-1B4D-0548-84FB-3496EAF06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4061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47B671-B3E2-4F0F-893E-01BA5A94BB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AA64CEE-1D32-9EE1-D14D-0F61BF68C1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65A75A-BDC3-1113-4132-926619AB6C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F1-E2F4-E14E-9734-C819C2A9CFE6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ECAE66-6758-787D-855A-6BAAB1E5EB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9F3DFC-D807-FE7B-72A5-66AECF48B6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9AAB8-1B4D-0548-84FB-3496EAF06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5899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49D314C-C492-F4A7-82F8-CDD9086E886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748E17-4422-22C0-B5A1-A3B28423D2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A713D6-2069-310A-18B7-BCBE57BE0B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F1-E2F4-E14E-9734-C819C2A9CFE6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21E275-8C50-FB12-6A36-2836688612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EF1842-22C4-B820-86E1-62EC390EAD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9AAB8-1B4D-0548-84FB-3496EAF06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89709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6CCA6E-5D1A-9466-FEBD-258138E86B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199D84-F7A5-AC28-E7DA-014F82EBDB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AA89B8-6923-4E4E-B053-7EC0F07AB3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F1-E2F4-E14E-9734-C819C2A9CFE6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CDC32F-B0F8-5870-0618-13957B18EE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0C16FA-F502-DDAB-CB77-2D1CCCE529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9AAB8-1B4D-0548-84FB-3496EAF06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8232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1C9184-1E0F-1BE3-DAC2-8CE62B1FFC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776D8C-4A8F-50C3-6A38-250FE09A1C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1044D0-3D40-C705-CBD5-D1BE5E7F4F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F1-E2F4-E14E-9734-C819C2A9CFE6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B05B3D-E04F-117D-4284-0FA45E0919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9A8F78-2C55-8C3A-830A-513760CCFE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9AAB8-1B4D-0548-84FB-3496EAF06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6321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21306B-ACF5-C0A8-B346-BC1F4EE129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F57871-0948-256A-C3C7-E4E1CAED55B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A2E2D80-8620-93C9-2C5A-51FDA141A3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6C61AF-1F40-1EF8-95A5-4980BE55ED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F1-E2F4-E14E-9734-C819C2A9CFE6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E4D91E-CEE4-9AF8-4622-98A2D1DB4F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336D24F-899D-D15B-DFA5-CAA0B716D2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9AAB8-1B4D-0548-84FB-3496EAF06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5700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6A69F7-DEBA-E3D8-3ECE-FA0FC384D2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DBB77D-17F3-95ED-4E2D-9F8840275D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572FF55-535F-CAED-7358-115F568A25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F15C7A0-DE72-BF69-2EDF-EAD186306A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1A471BD-29EB-5D97-5B85-B54BCF0FDDD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5D95539-2523-0A85-C289-AA093FF3FE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F1-E2F4-E14E-9734-C819C2A9CFE6}" type="datetimeFigureOut">
              <a:rPr lang="en-US" smtClean="0"/>
              <a:t>2/19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4D812B8-8BD4-EBD7-F555-93326D14E0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BA952A7-3F73-C550-7F35-B76D0D1CDE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9AAB8-1B4D-0548-84FB-3496EAF06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66998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9574D4-8C89-6131-7432-2BB1934C87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89C42BB-C265-B284-3162-9B2CD7FD66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F1-E2F4-E14E-9734-C819C2A9CFE6}" type="datetimeFigureOut">
              <a:rPr lang="en-US" smtClean="0"/>
              <a:t>2/19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D6FCE9C-C806-4394-77B9-7323C812A0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A869179-7A17-28EA-D476-6812155B86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9AAB8-1B4D-0548-84FB-3496EAF06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8845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D5B187C-8946-6B84-646B-E64526FE37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F1-E2F4-E14E-9734-C819C2A9CFE6}" type="datetimeFigureOut">
              <a:rPr lang="en-US" smtClean="0"/>
              <a:t>2/19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64A4AF4-2449-E8CD-5967-31F2582088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D6E61CD-98F2-3B59-8C73-2F8DA768D4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9AAB8-1B4D-0548-84FB-3496EAF06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4712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1691C9-71BA-2B06-99F7-F019F047F3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A9BBF9-8FA7-BCFB-B8E4-6F1B7201B8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A861C46-794F-7275-E6AA-6DB2DC5FFF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BBD9E2-3C46-C30A-4AB6-2B273D8994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F1-E2F4-E14E-9734-C819C2A9CFE6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457CCD-2E99-CC40-5E81-D0375BAB26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EBDEE4-DB39-8FC8-169B-4C55A48EC3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9AAB8-1B4D-0548-84FB-3496EAF06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0813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CA6F02-DF7C-6284-BA36-CB99899E43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619B0DE-C93D-3D0A-B8EB-0EE9065B3C5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C662BDB-4BEA-8A7F-D9DF-67E33C65F6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5FF8CA-EA5D-4D86-4405-15B1AB1E53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F1-E2F4-E14E-9734-C819C2A9CFE6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7BBCA3-FB6A-FE8B-0BF2-B0F3F89EE5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CBD5E9-B308-28B6-4721-BB13B97D30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9AAB8-1B4D-0548-84FB-3496EAF06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0747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CF824F9-0D2A-5255-1979-21B7D04FF9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75BA0C-5C33-56C3-EAC1-447885253E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3ABA82-A88C-49C7-8A07-98B902EB2CD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35596F1-E2F4-E14E-9734-C819C2A9CFE6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046E44-EEEC-3044-F423-04FE100F8E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C12412-A832-CD1C-58C8-7B77058BDC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049AAB8-1B4D-0548-84FB-3496EAF06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48093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49D7821F-6E40-5766-729C-E94A13246A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28950" y="0"/>
            <a:ext cx="6134100" cy="56642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B3A53A3-9BD1-4149-FA57-C9759F8E65A6}"/>
              </a:ext>
            </a:extLst>
          </p:cNvPr>
          <p:cNvSpPr txBox="1"/>
          <p:nvPr/>
        </p:nvSpPr>
        <p:spPr>
          <a:xfrm>
            <a:off x="0" y="5664200"/>
            <a:ext cx="12191999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 fontAlgn="base">
              <a:buNone/>
            </a:pPr>
            <a:r>
              <a:rPr lang="en-US" sz="1400" b="1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Figure S8: </a:t>
            </a:r>
            <a:r>
              <a:rPr lang="en-US" sz="1400" b="1" dirty="0" err="1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Alphafold</a:t>
            </a:r>
            <a:r>
              <a:rPr lang="en-US" sz="1400" b="1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 2 modeling of the hFlex3a2_v2 variable domains</a:t>
            </a:r>
            <a:r>
              <a:rPr lang="en-US" sz="1400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. (A) Plots showing the predicted alignment error (PAE) for chain A (VL) and chain B (VH) for the top five ranked output structures, following the </a:t>
            </a:r>
            <a:r>
              <a:rPr lang="en-US" sz="1400" dirty="0" err="1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Alphafold</a:t>
            </a:r>
            <a:r>
              <a:rPr lang="en-US" sz="1400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 2 multimer run using </a:t>
            </a:r>
            <a:r>
              <a:rPr lang="en-US" sz="1400" dirty="0" err="1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ColabFold</a:t>
            </a:r>
            <a:r>
              <a:rPr lang="en-US" sz="1400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. (B) Plot showing sequence alignments used for the </a:t>
            </a:r>
            <a:r>
              <a:rPr lang="en-US" sz="1400" dirty="0" err="1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Alphafold</a:t>
            </a:r>
            <a:r>
              <a:rPr lang="en-US" sz="1400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 model. (C) A superposition of the top 5 ranked structures from the </a:t>
            </a:r>
            <a:r>
              <a:rPr lang="en-US" sz="1400" dirty="0" err="1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Alphafold</a:t>
            </a:r>
            <a:r>
              <a:rPr lang="en-US" sz="1400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 run, colored by </a:t>
            </a:r>
            <a:r>
              <a:rPr lang="en-US" sz="1400" dirty="0" err="1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pLDDT</a:t>
            </a:r>
            <a:r>
              <a:rPr lang="en-US" sz="1400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. The five structures were virtually indistinguishable, with RMSD &lt;0.2 Å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2</a:t>
            </a:r>
            <a:r>
              <a:rPr lang="en-US" sz="1400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, and all had similar </a:t>
            </a:r>
            <a:r>
              <a:rPr lang="en-US" sz="1400" dirty="0" err="1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pLDDT</a:t>
            </a:r>
            <a:r>
              <a:rPr lang="en-US" sz="1400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 and </a:t>
            </a:r>
            <a:r>
              <a:rPr lang="en-US" sz="1400" dirty="0" err="1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pTM</a:t>
            </a:r>
            <a:r>
              <a:rPr lang="en-US" sz="1400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 scores. (D) Plots showing </a:t>
            </a:r>
            <a:r>
              <a:rPr lang="en-US" sz="1400" dirty="0" err="1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pLDDT</a:t>
            </a:r>
            <a:r>
              <a:rPr lang="en-US" sz="1400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 per residue position for each of the top five ranked models for the hFlex3a2 the and VH.</a:t>
            </a:r>
            <a:endParaRPr lang="en-US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545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4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yden Schmidt</dc:creator>
  <cp:lastModifiedBy>Hayden Schmidt</cp:lastModifiedBy>
  <cp:revision>1</cp:revision>
  <dcterms:created xsi:type="dcterms:W3CDTF">2026-02-19T23:46:59Z</dcterms:created>
  <dcterms:modified xsi:type="dcterms:W3CDTF">2026-02-19T23:47:15Z</dcterms:modified>
</cp:coreProperties>
</file>